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move the slide</a:t>
            </a:r>
            <a:endParaRPr b="0" lang="en-US" sz="2400" spc="-1" strike="noStrike">
              <a:solidFill>
                <a:srgbClr val="0000ff"/>
              </a:solidFill>
              <a:latin typeface="Comic Sans MS"/>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1108FF2-6918-4FB0-8615-A2D78AB3607C}"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sldImg"/>
          </p:nvPr>
        </p:nvSpPr>
        <p:spPr>
          <a:xfrm>
            <a:off x="1143000" y="685800"/>
            <a:ext cx="4572000" cy="3429000"/>
          </a:xfrm>
          <a:prstGeom prst="rect">
            <a:avLst/>
          </a:prstGeom>
          <a:ln w="0">
            <a:noFill/>
          </a:ln>
        </p:spPr>
      </p:sp>
      <p:sp>
        <p:nvSpPr>
          <p:cNvPr id="5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DF5E411-FA23-4C78-A6A5-BFD17B8B157B}"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923B0A5-838C-4CA7-85B5-B664ADEC408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5F51ABC-A7A1-4498-B5CE-E950C5EC8E9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0B16D33-A0B0-4765-B285-18BBD8D4151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FB3EE59-25DC-42FE-A4F8-82B9CE3233E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C5203C8-3D4A-4068-A61D-A566F45112B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7294D8-45BB-444D-81B3-72C9785CB6D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1E4001-A829-4C97-97F9-91DFD27AE00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AC63988-EFE8-4BBA-BF41-558FDC7E33D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AF24D6F-E0DB-43ED-ADB1-2280426397A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32EC95-88BE-4918-AD8C-BF70EFB3DD0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735BF80-86F1-4B79-979A-6D258A4EED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07019B-6008-4A23-BCDC-CBE4ED14AD1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6BFCD51-6638-4EB6-A9B1-8E4F3370D4D8}"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Chart 6" descr=""/>
          <p:cNvPicPr/>
          <p:nvPr/>
        </p:nvPicPr>
        <p:blipFill>
          <a:blip r:embed="rId1"/>
          <a:stretch/>
        </p:blipFill>
        <p:spPr>
          <a:xfrm>
            <a:off x="2286000" y="1371600"/>
            <a:ext cx="4572000" cy="2743200"/>
          </a:xfrm>
          <a:prstGeom prst="rect">
            <a:avLst/>
          </a:prstGeom>
          <a:ln w="0">
            <a:noFill/>
          </a:ln>
        </p:spPr>
      </p:pic>
      <p:sp>
        <p:nvSpPr>
          <p:cNvPr id="49" name="TextBox 5"/>
          <p:cNvSpPr/>
          <p:nvPr/>
        </p:nvSpPr>
        <p:spPr>
          <a:xfrm>
            <a:off x="-14400" y="4059360"/>
            <a:ext cx="914400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7 Addition of 500mM sorbitol did not improve lycopene yield</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espite addition of 500mM sorbitol increased solubility of dxs and flux through the DXP pathway (Figure 4 and Additional file 4), it did not increase yield of lycopene when lycopene synthetic genes were expressed. This is because one enzyme in the downstream part of the DXP pathway (ISPG) was severely rate-limiting in lycopene synthesis (Zhou et al. PLoS One, In Pres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3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11-08T04:13:02Z</dcterms:modified>
  <cp:revision>92</cp:revision>
  <dc:subject/>
  <dc:title>Slide 1</dc:title>
</cp:coreProperties>
</file>